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  <p15:guide id="3" orient="horz" pos="1603">
          <p15:clr>
            <a:srgbClr val="A4A3A4"/>
          </p15:clr>
        </p15:guide>
        <p15:guide id="4" pos="426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D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30" y="108"/>
      </p:cViewPr>
      <p:guideLst>
        <p:guide orient="horz" pos="2160"/>
        <p:guide pos="3120"/>
        <p:guide orient="horz" pos="1603"/>
        <p:guide pos="426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0B5627-B992-45E2-9B92-24BA9FB6DF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15F3A6-9FC2-4E6F-80C8-4677BE6C9A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2070F-BFB8-4CCB-A7AA-07486BCAF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4D7859-3A7E-4B39-BE59-80F3F0D0B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89E2FD-0824-48D0-AD3C-228F64164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413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4C736-D33A-4A6A-80CD-E25FCFD19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52D93B-36D1-4E24-AC74-A1DCDD5A4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D2A048-3536-49EA-9A0C-7A275595F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C29B9-49EF-43E2-B55D-52CD2625A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145D6-E413-4C72-A188-892AF2CCC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587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D552FE-A63D-4DCF-9F81-022EF13EE1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386E95-B1D2-4B37-B149-97FBA126AA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4CD4B4-38EE-42EA-A786-F4337C13B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CE1FE-8281-4176-AD75-9C243DFAC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D40CEF-58E7-472E-A980-138EB9AE1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358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F3F5E-E1BE-41F9-A98B-ADD98C6BE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471317-46D6-4670-B664-83E62A9B97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5F5F3-4A1C-41BC-8E2A-86ED3700B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A15D4-4616-4595-BE6F-9DFA3D1F9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C6DA35-9A74-477E-90AC-1C2D9D045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986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7D2F5-0F1C-462B-AB8A-89F7BF22C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4A9EDF-E13D-48A4-8B1D-4B78716E0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0FDE40-D151-4CA5-9A7B-6CBE317EA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6EF557-5A11-42ED-91B5-CEC097B8A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267314-4BF9-436C-83EB-34F96AE0D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68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9FAA9-7481-4B74-85AE-B09163281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81BB4C-D7EF-472E-8B31-1BBC3C228F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191BE6-D992-4B42-9FDC-0BE4DC1530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D29B0B-ECAD-423B-9A8C-3BBF445CA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3D06B9-2A92-42C7-BAD3-E74AD61F6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BFCC75-0CF5-469A-9180-86F4E1435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509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F09CB-F0C2-464B-A581-FEEB6925E7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D3B43E-6212-46EB-B778-6E8883FEB6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88C2F7-D814-4DD8-A220-591DF0FCCD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B964EF-47A8-4B9E-B089-B39B8634A8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9071EE-0922-4E41-970F-9EFE821825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36306E-50C9-4CDF-946C-02BA210FE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857313-AA74-462D-9BAE-35286333A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77744D-261D-4468-84D3-CD8B0AD14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2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95056-E490-4A7C-9592-93F50A516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AECD41-9B21-4DF1-AD2A-C78CE7A27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16DD57-E7DD-408D-BAE9-D4C2EEACC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5D4BA4-DFE0-4416-82DE-496157C51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11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E82504-3409-4D52-82EB-7041AC075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10451B-FC64-41F8-AABA-76BEECCF0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BCB95D-A448-4151-8FD2-D37FDBB89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578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E8D6F-E7A7-44B0-A3E6-4678EA6CC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8EEE45-1A03-4560-88C8-5B0C1CC51B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CF7CA9-8CA1-4369-B43E-BDE93BEA64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39D9EE-AE85-4805-8CAD-4F6A57379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73A5C7-6729-4FB8-9006-D22E58910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7C07B0-6527-4897-BC6E-AED70A1F7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001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60AC7-CBD3-4BD7-8CF8-78A65239A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C4782D-0545-4EA5-87F4-88A665B102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9ABAB3-8028-4FF4-AC48-7DAC984AD1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D1C226-38BC-4FEC-A8E2-4D9BDAFA8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218E07-4348-4019-9BCE-71073AEF7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009EAC-7C6A-48DB-BFEF-3FE4F3EA4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639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2328AC-5D61-41AA-BEDE-0EDFE2E73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594A03-1766-4184-AECD-E60CC531D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82757-8D2B-46B8-BAD9-05440565B0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FC6BA-10D2-4A5F-9788-7CD616D4767B}" type="datetimeFigureOut">
              <a:rPr lang="en-US" smtClean="0"/>
              <a:t>8/12/20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0359AD-6BA8-4934-9064-F493A5F9D4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9887B-7B28-44D3-8A2E-5D10DF0FB4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0338E-3C7D-4181-9FAC-3E381DEAE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07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7" name="Group 136"/>
          <p:cNvGrpSpPr/>
          <p:nvPr/>
        </p:nvGrpSpPr>
        <p:grpSpPr>
          <a:xfrm rot="18070102">
            <a:off x="5909792" y="3682792"/>
            <a:ext cx="515267" cy="163893"/>
            <a:chOff x="5745737" y="1931934"/>
            <a:chExt cx="515267" cy="163893"/>
          </a:xfrm>
        </p:grpSpPr>
        <p:sp>
          <p:nvSpPr>
            <p:cNvPr id="139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5902306" y="1775365"/>
              <a:ext cx="99066" cy="412204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rot="3529898" flipH="1" flipV="1">
              <a:off x="6113547" y="1948371"/>
              <a:ext cx="118399" cy="176514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41" name="Group 40"/>
          <p:cNvGrpSpPr/>
          <p:nvPr/>
        </p:nvGrpSpPr>
        <p:grpSpPr>
          <a:xfrm rot="1060809">
            <a:off x="5346319" y="925892"/>
            <a:ext cx="523277" cy="109632"/>
            <a:chOff x="5820991" y="996607"/>
            <a:chExt cx="185751" cy="228600"/>
          </a:xfrm>
        </p:grpSpPr>
        <p:sp>
          <p:nvSpPr>
            <p:cNvPr id="27" name="Line 4">
              <a:extLst>
                <a:ext uri="{FF2B5EF4-FFF2-40B4-BE49-F238E27FC236}">
                  <a16:creationId xmlns:a16="http://schemas.microsoft.com/office/drawing/2014/main" id="{73B3CD0C-14F0-40CE-B676-61C73BCD59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006742" y="996607"/>
              <a:ext cx="0" cy="2286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Line 3">
              <a:extLst>
                <a:ext uri="{FF2B5EF4-FFF2-40B4-BE49-F238E27FC236}">
                  <a16:creationId xmlns:a16="http://schemas.microsoft.com/office/drawing/2014/main" id="{CCB2E25D-0A74-444B-8643-EBFF6B7665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20991" y="1106239"/>
              <a:ext cx="185751" cy="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 Box 15">
            <a:extLst>
              <a:ext uri="{FF2B5EF4-FFF2-40B4-BE49-F238E27FC236}">
                <a16:creationId xmlns:a16="http://schemas.microsoft.com/office/drawing/2014/main" id="{4CFB995A-EDD5-4C89-9BF1-6E5302F1B4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0605" y="5272780"/>
            <a:ext cx="803573" cy="290512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</p:txBody>
      </p:sp>
      <p:sp>
        <p:nvSpPr>
          <p:cNvPr id="59" name="Text Box 26">
            <a:extLst>
              <a:ext uri="{FF2B5EF4-FFF2-40B4-BE49-F238E27FC236}">
                <a16:creationId xmlns:a16="http://schemas.microsoft.com/office/drawing/2014/main" id="{EBFED8E5-B71A-4AE7-B7A8-DA88412700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2285" y="2667113"/>
            <a:ext cx="809078" cy="326022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OS</a:t>
            </a:r>
            <a:endParaRPr lang="fr-F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 Box 27">
            <a:extLst>
              <a:ext uri="{FF2B5EF4-FFF2-40B4-BE49-F238E27FC236}">
                <a16:creationId xmlns:a16="http://schemas.microsoft.com/office/drawing/2014/main" id="{D99949A8-DE6F-47B8-9D8C-CBB81894F4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2234" y="3573645"/>
            <a:ext cx="823094" cy="272617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VEGF</a:t>
            </a:r>
          </a:p>
        </p:txBody>
      </p:sp>
      <p:sp>
        <p:nvSpPr>
          <p:cNvPr id="66" name="Text Box 33">
            <a:extLst>
              <a:ext uri="{FF2B5EF4-FFF2-40B4-BE49-F238E27FC236}">
                <a16:creationId xmlns:a16="http://schemas.microsoft.com/office/drawing/2014/main" id="{2B61FAF4-1AC9-4F1D-B393-16C71802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7469" y="5274639"/>
            <a:ext cx="1260235" cy="292992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giogenesis</a:t>
            </a:r>
            <a:endParaRPr lang="fr-F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Line 38">
            <a:extLst>
              <a:ext uri="{FF2B5EF4-FFF2-40B4-BE49-F238E27FC236}">
                <a16:creationId xmlns:a16="http://schemas.microsoft.com/office/drawing/2014/main" id="{7608897B-16B7-4771-9A0D-717E41EA7230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0855" y="3071351"/>
            <a:ext cx="0" cy="37621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1200" b="1">
              <a:solidFill>
                <a:srgbClr val="000000"/>
              </a:solidFill>
              <a:latin typeface="Arial" panose="020B0604020202020204" pitchFamily="34" charset="0"/>
              <a:ea typeface="Gulim" panose="020B0600000101010101" pitchFamily="34" charset="-127"/>
              <a:cs typeface="Arial" panose="020B0604020202020204" pitchFamily="34" charset="0"/>
            </a:endParaRPr>
          </a:p>
        </p:txBody>
      </p:sp>
      <p:sp>
        <p:nvSpPr>
          <p:cNvPr id="104" name="Text Box 78">
            <a:extLst>
              <a:ext uri="{FF2B5EF4-FFF2-40B4-BE49-F238E27FC236}">
                <a16:creationId xmlns:a16="http://schemas.microsoft.com/office/drawing/2014/main" id="{04810ACC-12E1-4A7B-9887-A7792E84BE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8191" y="6216776"/>
            <a:ext cx="8489618" cy="447376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mprove</a:t>
            </a:r>
            <a:r>
              <a:rPr lang="fr-F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cardiac</a:t>
            </a:r>
            <a:r>
              <a:rPr lang="fr-F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fr-F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alt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myocardial</a:t>
            </a:r>
            <a:r>
              <a:rPr lang="fr-F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nfraction (MI)</a:t>
            </a:r>
          </a:p>
        </p:txBody>
      </p:sp>
      <p:sp>
        <p:nvSpPr>
          <p:cNvPr id="111" name="Text Box 14">
            <a:extLst>
              <a:ext uri="{FF2B5EF4-FFF2-40B4-BE49-F238E27FC236}">
                <a16:creationId xmlns:a16="http://schemas.microsoft.com/office/drawing/2014/main" id="{ECDB9746-CF70-405F-B19C-19AB586163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47576" y="3568599"/>
            <a:ext cx="653283" cy="276999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9pPr>
          </a:lstStyle>
          <a:p>
            <a:r>
              <a:rPr lang="fr-FR" altLang="en-US" dirty="0"/>
              <a:t>Akt</a:t>
            </a:r>
          </a:p>
        </p:txBody>
      </p:sp>
      <p:sp>
        <p:nvSpPr>
          <p:cNvPr id="112" name="Line 11">
            <a:extLst>
              <a:ext uri="{FF2B5EF4-FFF2-40B4-BE49-F238E27FC236}">
                <a16:creationId xmlns:a16="http://schemas.microsoft.com/office/drawing/2014/main" id="{479522F8-05B7-4D83-A563-EC675D635FD3}"/>
              </a:ext>
            </a:extLst>
          </p:cNvPr>
          <p:cNvSpPr>
            <a:spLocks noChangeShapeType="1"/>
          </p:cNvSpPr>
          <p:nvPr/>
        </p:nvSpPr>
        <p:spPr bwMode="auto">
          <a:xfrm>
            <a:off x="4506574" y="3081710"/>
            <a:ext cx="8530" cy="443355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Line 11">
            <a:extLst>
              <a:ext uri="{FF2B5EF4-FFF2-40B4-BE49-F238E27FC236}">
                <a16:creationId xmlns:a16="http://schemas.microsoft.com/office/drawing/2014/main" id="{99A9770C-F9B5-4097-99F7-C595B3BEA6D2}"/>
              </a:ext>
            </a:extLst>
          </p:cNvPr>
          <p:cNvSpPr>
            <a:spLocks noChangeShapeType="1"/>
          </p:cNvSpPr>
          <p:nvPr/>
        </p:nvSpPr>
        <p:spPr bwMode="auto">
          <a:xfrm>
            <a:off x="3111645" y="1225206"/>
            <a:ext cx="3121536" cy="2222361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Line 11">
            <a:extLst>
              <a:ext uri="{FF2B5EF4-FFF2-40B4-BE49-F238E27FC236}">
                <a16:creationId xmlns:a16="http://schemas.microsoft.com/office/drawing/2014/main" id="{8F11B6B6-D12A-4883-89EC-B6EAFB1E23E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501876" y="4096210"/>
            <a:ext cx="8963" cy="94385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Group 42"/>
          <p:cNvGrpSpPr/>
          <p:nvPr/>
        </p:nvGrpSpPr>
        <p:grpSpPr>
          <a:xfrm>
            <a:off x="1926019" y="700884"/>
            <a:ext cx="1055553" cy="1011745"/>
            <a:chOff x="1748595" y="359684"/>
            <a:chExt cx="1055553" cy="1011745"/>
          </a:xfrm>
        </p:grpSpPr>
        <p:sp>
          <p:nvSpPr>
            <p:cNvPr id="4" name="Rectangle 26">
              <a:extLst>
                <a:ext uri="{FF2B5EF4-FFF2-40B4-BE49-F238E27FC236}">
                  <a16:creationId xmlns:a16="http://schemas.microsoft.com/office/drawing/2014/main" id="{CC669144-C992-47C7-8543-2B272C6FB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8595" y="359684"/>
              <a:ext cx="18473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6B173762-B16D-4401-B6D0-8EFD4ADEB951}"/>
                </a:ext>
              </a:extLst>
            </p:cNvPr>
            <p:cNvGrpSpPr/>
            <p:nvPr/>
          </p:nvGrpSpPr>
          <p:grpSpPr>
            <a:xfrm>
              <a:off x="1833256" y="434090"/>
              <a:ext cx="928169" cy="472663"/>
              <a:chOff x="4788190" y="2504260"/>
              <a:chExt cx="922946" cy="472663"/>
            </a:xfrm>
          </p:grpSpPr>
          <p:sp>
            <p:nvSpPr>
              <p:cNvPr id="33" name="Oval 32">
                <a:extLst>
                  <a:ext uri="{FF2B5EF4-FFF2-40B4-BE49-F238E27FC236}">
                    <a16:creationId xmlns:a16="http://schemas.microsoft.com/office/drawing/2014/main" id="{AFC49980-7858-47EB-A972-8513A380F58B}"/>
                  </a:ext>
                </a:extLst>
              </p:cNvPr>
              <p:cNvSpPr/>
              <p:nvPr/>
            </p:nvSpPr>
            <p:spPr>
              <a:xfrm>
                <a:off x="4788190" y="2504260"/>
                <a:ext cx="922946" cy="472663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 Box 17">
                <a:extLst>
                  <a:ext uri="{FF2B5EF4-FFF2-40B4-BE49-F238E27FC236}">
                    <a16:creationId xmlns:a16="http://schemas.microsoft.com/office/drawing/2014/main" id="{5B26E397-DF3A-4F3A-9B6F-AEC9E516841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90227" y="2611185"/>
                <a:ext cx="718872" cy="3524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BBE0E3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Gulim" panose="020B0600000101010101" pitchFamily="34" charset="-127"/>
                    <a:cs typeface="Arial" panose="020B0604020202020204" pitchFamily="34" charset="0"/>
                  </a:rPr>
                  <a:t>SDF-1</a:t>
                </a:r>
                <a:r>
                  <a:rPr kumimoji="0" lang="el-GR" altLang="ko-KR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Gulim" panose="020B0600000101010101" pitchFamily="34" charset="-127"/>
                    <a:cs typeface="Arial" panose="020B0604020202020204" pitchFamily="34" charset="0"/>
                  </a:rPr>
                  <a:t>α</a:t>
                </a:r>
                <a:endParaRPr kumimoji="0" lang="en-US" altLang="ko-KR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6" name="Text Box 16">
              <a:extLst>
                <a:ext uri="{FF2B5EF4-FFF2-40B4-BE49-F238E27FC236}">
                  <a16:creationId xmlns:a16="http://schemas.microsoft.com/office/drawing/2014/main" id="{90525842-94ED-4C1C-86F5-846459533D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20816" y="1065261"/>
              <a:ext cx="883332" cy="3061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R="0" lvl="0" indent="0" algn="ctr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 kumimoji="0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Gulim" panose="020B0600000101010101" pitchFamily="34" charset="-127"/>
                  <a:cs typeface="Times New Roman" panose="02020603050405020304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fr-FR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XCR4</a:t>
              </a:r>
            </a:p>
          </p:txBody>
        </p:sp>
        <p:sp>
          <p:nvSpPr>
            <p:cNvPr id="115" name="Freeform 4">
              <a:extLst>
                <a:ext uri="{FF2B5EF4-FFF2-40B4-BE49-F238E27FC236}">
                  <a16:creationId xmlns:a16="http://schemas.microsoft.com/office/drawing/2014/main" id="{42E838A8-2DBE-4DB5-A51E-4376CBA95F3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8696" y="927820"/>
              <a:ext cx="482445" cy="200330"/>
            </a:xfrm>
            <a:custGeom>
              <a:avLst/>
              <a:gdLst>
                <a:gd name="T0" fmla="*/ 0 w 408"/>
                <a:gd name="T1" fmla="*/ 0 h 450"/>
                <a:gd name="T2" fmla="*/ 160407275 w 408"/>
                <a:gd name="T3" fmla="*/ 2147478457 h 450"/>
                <a:gd name="T4" fmla="*/ 160407275 w 408"/>
                <a:gd name="T5" fmla="*/ 2147478457 h 450"/>
                <a:gd name="T6" fmla="*/ 160407275 w 408"/>
                <a:gd name="T7" fmla="*/ 2147478457 h 450"/>
                <a:gd name="T8" fmla="*/ 160407275 w 408"/>
                <a:gd name="T9" fmla="*/ 2147478457 h 450"/>
                <a:gd name="T10" fmla="*/ 160407275 w 408"/>
                <a:gd name="T11" fmla="*/ 2147478457 h 450"/>
                <a:gd name="T12" fmla="*/ 160407275 w 408"/>
                <a:gd name="T13" fmla="*/ 2147478457 h 450"/>
                <a:gd name="T14" fmla="*/ 160407275 w 408"/>
                <a:gd name="T15" fmla="*/ 2147478457 h 450"/>
                <a:gd name="T16" fmla="*/ 160407275 w 408"/>
                <a:gd name="T17" fmla="*/ 2147478457 h 450"/>
                <a:gd name="T18" fmla="*/ 160407275 w 408"/>
                <a:gd name="T19" fmla="*/ 2147478457 h 450"/>
                <a:gd name="T20" fmla="*/ 160407275 w 408"/>
                <a:gd name="T21" fmla="*/ 2147478457 h 450"/>
                <a:gd name="T22" fmla="*/ 160407275 w 408"/>
                <a:gd name="T23" fmla="*/ 2147478457 h 450"/>
                <a:gd name="T24" fmla="*/ 160407275 w 408"/>
                <a:gd name="T25" fmla="*/ 2147478457 h 450"/>
                <a:gd name="T26" fmla="*/ 160407275 w 408"/>
                <a:gd name="T27" fmla="*/ 2147478457 h 450"/>
                <a:gd name="T28" fmla="*/ 160407275 w 408"/>
                <a:gd name="T29" fmla="*/ 2147478457 h 450"/>
                <a:gd name="T30" fmla="*/ 160407275 w 408"/>
                <a:gd name="T31" fmla="*/ 2147478457 h 450"/>
                <a:gd name="T32" fmla="*/ 160407275 w 408"/>
                <a:gd name="T33" fmla="*/ 2147478457 h 450"/>
                <a:gd name="T34" fmla="*/ 160407275 w 408"/>
                <a:gd name="T35" fmla="*/ 2147478457 h 450"/>
                <a:gd name="T36" fmla="*/ 160407275 w 408"/>
                <a:gd name="T37" fmla="*/ 2147478457 h 450"/>
                <a:gd name="T38" fmla="*/ 160407275 w 408"/>
                <a:gd name="T39" fmla="*/ 2147478457 h 450"/>
                <a:gd name="T40" fmla="*/ 160407275 w 408"/>
                <a:gd name="T41" fmla="*/ 2147478457 h 450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w 408"/>
                <a:gd name="T64" fmla="*/ 0 h 450"/>
                <a:gd name="T65" fmla="*/ 408 w 408"/>
                <a:gd name="T66" fmla="*/ 450 h 450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T63" t="T64" r="T65" b="T66"/>
              <a:pathLst>
                <a:path w="408" h="450">
                  <a:moveTo>
                    <a:pt x="0" y="0"/>
                  </a:moveTo>
                  <a:cubicBezTo>
                    <a:pt x="24" y="8"/>
                    <a:pt x="28" y="18"/>
                    <a:pt x="36" y="42"/>
                  </a:cubicBezTo>
                  <a:cubicBezTo>
                    <a:pt x="37" y="68"/>
                    <a:pt x="10" y="247"/>
                    <a:pt x="72" y="288"/>
                  </a:cubicBezTo>
                  <a:cubicBezTo>
                    <a:pt x="102" y="278"/>
                    <a:pt x="93" y="287"/>
                    <a:pt x="96" y="240"/>
                  </a:cubicBezTo>
                  <a:cubicBezTo>
                    <a:pt x="96" y="234"/>
                    <a:pt x="75" y="37"/>
                    <a:pt x="132" y="18"/>
                  </a:cubicBezTo>
                  <a:cubicBezTo>
                    <a:pt x="174" y="46"/>
                    <a:pt x="156" y="108"/>
                    <a:pt x="144" y="150"/>
                  </a:cubicBezTo>
                  <a:cubicBezTo>
                    <a:pt x="140" y="166"/>
                    <a:pt x="132" y="198"/>
                    <a:pt x="132" y="198"/>
                  </a:cubicBezTo>
                  <a:cubicBezTo>
                    <a:pt x="134" y="228"/>
                    <a:pt x="122" y="297"/>
                    <a:pt x="168" y="282"/>
                  </a:cubicBezTo>
                  <a:cubicBezTo>
                    <a:pt x="176" y="258"/>
                    <a:pt x="184" y="234"/>
                    <a:pt x="192" y="210"/>
                  </a:cubicBezTo>
                  <a:cubicBezTo>
                    <a:pt x="196" y="198"/>
                    <a:pt x="204" y="174"/>
                    <a:pt x="204" y="174"/>
                  </a:cubicBezTo>
                  <a:cubicBezTo>
                    <a:pt x="207" y="127"/>
                    <a:pt x="198" y="38"/>
                    <a:pt x="246" y="6"/>
                  </a:cubicBezTo>
                  <a:cubicBezTo>
                    <a:pt x="302" y="89"/>
                    <a:pt x="211" y="240"/>
                    <a:pt x="300" y="300"/>
                  </a:cubicBezTo>
                  <a:cubicBezTo>
                    <a:pt x="332" y="289"/>
                    <a:pt x="320" y="299"/>
                    <a:pt x="324" y="246"/>
                  </a:cubicBezTo>
                  <a:cubicBezTo>
                    <a:pt x="325" y="228"/>
                    <a:pt x="324" y="60"/>
                    <a:pt x="348" y="30"/>
                  </a:cubicBezTo>
                  <a:cubicBezTo>
                    <a:pt x="356" y="19"/>
                    <a:pt x="372" y="16"/>
                    <a:pt x="384" y="12"/>
                  </a:cubicBezTo>
                  <a:cubicBezTo>
                    <a:pt x="389" y="55"/>
                    <a:pt x="401" y="95"/>
                    <a:pt x="408" y="138"/>
                  </a:cubicBezTo>
                  <a:cubicBezTo>
                    <a:pt x="402" y="199"/>
                    <a:pt x="391" y="248"/>
                    <a:pt x="372" y="306"/>
                  </a:cubicBezTo>
                  <a:cubicBezTo>
                    <a:pt x="370" y="312"/>
                    <a:pt x="360" y="359"/>
                    <a:pt x="348" y="360"/>
                  </a:cubicBezTo>
                  <a:cubicBezTo>
                    <a:pt x="266" y="368"/>
                    <a:pt x="184" y="364"/>
                    <a:pt x="102" y="366"/>
                  </a:cubicBezTo>
                  <a:cubicBezTo>
                    <a:pt x="74" y="375"/>
                    <a:pt x="54" y="380"/>
                    <a:pt x="30" y="396"/>
                  </a:cubicBezTo>
                  <a:cubicBezTo>
                    <a:pt x="25" y="416"/>
                    <a:pt x="15" y="431"/>
                    <a:pt x="24" y="450"/>
                  </a:cubicBezTo>
                </a:path>
              </a:pathLst>
            </a:custGeom>
            <a:ln>
              <a:headEnd/>
              <a:tailEnd/>
            </a:ln>
            <a:extLst/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1200" b="1">
                <a:solidFill>
                  <a:srgbClr val="000000"/>
                </a:solidFill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endParaRPr>
            </a:p>
          </p:txBody>
        </p:sp>
      </p:grpSp>
      <p:cxnSp>
        <p:nvCxnSpPr>
          <p:cNvPr id="30" name="Straight Arrow Connector 29"/>
          <p:cNvCxnSpPr/>
          <p:nvPr/>
        </p:nvCxnSpPr>
        <p:spPr>
          <a:xfrm>
            <a:off x="2810833" y="1724369"/>
            <a:ext cx="565600" cy="804069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6" name="Straight Arrow Connector 35"/>
          <p:cNvCxnSpPr/>
          <p:nvPr/>
        </p:nvCxnSpPr>
        <p:spPr>
          <a:xfrm>
            <a:off x="3458359" y="4061177"/>
            <a:ext cx="15009" cy="109728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8" name="Text Box 14">
            <a:extLst>
              <a:ext uri="{FF2B5EF4-FFF2-40B4-BE49-F238E27FC236}">
                <a16:creationId xmlns:a16="http://schemas.microsoft.com/office/drawing/2014/main" id="{ECDB9746-CF70-405F-B19C-19AB586163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9604" y="2666801"/>
            <a:ext cx="664544" cy="326334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9pPr>
          </a:lstStyle>
          <a:p>
            <a:r>
              <a:rPr lang="fr-FR" altLang="en-US" dirty="0"/>
              <a:t>PI3K</a:t>
            </a:r>
          </a:p>
        </p:txBody>
      </p:sp>
      <p:sp>
        <p:nvSpPr>
          <p:cNvPr id="131" name="Text Box 14">
            <a:extLst>
              <a:ext uri="{FF2B5EF4-FFF2-40B4-BE49-F238E27FC236}">
                <a16:creationId xmlns:a16="http://schemas.microsoft.com/office/drawing/2014/main" id="{C00A0E5A-A1E3-4419-B164-3528BAF10B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698" y="2647248"/>
            <a:ext cx="1409719" cy="360518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bilization</a:t>
            </a:r>
            <a:endParaRPr lang="fr-F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 Box 17">
            <a:extLst>
              <a:ext uri="{FF2B5EF4-FFF2-40B4-BE49-F238E27FC236}">
                <a16:creationId xmlns:a16="http://schemas.microsoft.com/office/drawing/2014/main" id="{2D493CE8-F2C8-4838-8FE3-832769F772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399" y="3573134"/>
            <a:ext cx="1691582" cy="642532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oming &amp; </a:t>
            </a:r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graftment</a:t>
            </a:r>
            <a:r>
              <a:rPr lang="fr-F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stem </a:t>
            </a:r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Straight Arrow Connector 133"/>
          <p:cNvCxnSpPr/>
          <p:nvPr/>
        </p:nvCxnSpPr>
        <p:spPr>
          <a:xfrm>
            <a:off x="2425085" y="1700673"/>
            <a:ext cx="0" cy="82296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36" name="Straight Arrow Connector 135"/>
          <p:cNvCxnSpPr/>
          <p:nvPr/>
        </p:nvCxnSpPr>
        <p:spPr>
          <a:xfrm flipH="1">
            <a:off x="933255" y="1680180"/>
            <a:ext cx="1250885" cy="1767388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" name="Text Box 19">
            <a:extLst>
              <a:ext uri="{FF2B5EF4-FFF2-40B4-BE49-F238E27FC236}">
                <a16:creationId xmlns:a16="http://schemas.microsoft.com/office/drawing/2014/main" id="{AB83D9AE-CB7A-45D7-9966-D556A37719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2808" y="1971826"/>
            <a:ext cx="1216447" cy="37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cGKs</a:t>
            </a: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/PKG</a:t>
            </a: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18">
            <a:extLst>
              <a:ext uri="{FF2B5EF4-FFF2-40B4-BE49-F238E27FC236}">
                <a16:creationId xmlns:a16="http://schemas.microsoft.com/office/drawing/2014/main" id="{122A6AFC-4BCF-4010-9B72-8A5FCCA570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1909" y="2523936"/>
            <a:ext cx="940552" cy="37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P-VASP</a:t>
            </a: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6351821" y="2993135"/>
            <a:ext cx="1039717" cy="397592"/>
            <a:chOff x="6172732" y="3807055"/>
            <a:chExt cx="1039717" cy="397592"/>
          </a:xfrm>
        </p:grpSpPr>
        <p:sp>
          <p:nvSpPr>
            <p:cNvPr id="7" name="Oval 24">
              <a:extLst>
                <a:ext uri="{FF2B5EF4-FFF2-40B4-BE49-F238E27FC236}">
                  <a16:creationId xmlns:a16="http://schemas.microsoft.com/office/drawing/2014/main" id="{A3B150BD-F36A-45FA-A98E-60E53B0C4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2732" y="3828159"/>
              <a:ext cx="898433" cy="303485"/>
            </a:xfrm>
            <a:prstGeom prst="ellipse">
              <a:avLst/>
            </a:prstGeom>
            <a:gradFill rotWithShape="1">
              <a:gsLst>
                <a:gs pos="0">
                  <a:srgbClr val="FF99FF"/>
                </a:gs>
                <a:gs pos="50000">
                  <a:srgbClr val="FFFFFF"/>
                </a:gs>
                <a:gs pos="100000">
                  <a:srgbClr val="FF99FF"/>
                </a:gs>
              </a:gsLst>
              <a:lin ang="5400000" scaled="1"/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 Box 17">
              <a:extLst>
                <a:ext uri="{FF2B5EF4-FFF2-40B4-BE49-F238E27FC236}">
                  <a16:creationId xmlns:a16="http://schemas.microsoft.com/office/drawing/2014/main" id="{CB42FBBD-79D6-4505-9630-E3D53948B5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64514" y="3807055"/>
              <a:ext cx="947935" cy="397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1200" b="1" dirty="0">
                  <a:solidFill>
                    <a:srgbClr val="000000"/>
                  </a:solidFill>
                  <a:latin typeface="Arial" panose="020B0604020202020204" pitchFamily="34" charset="0"/>
                  <a:ea typeface="Gulim" panose="020B0600000101010101" pitchFamily="34" charset="-127"/>
                  <a:cs typeface="Arial" panose="020B0604020202020204" pitchFamily="34" charset="0"/>
                </a:rPr>
                <a:t>p</a:t>
              </a:r>
              <a:r>
                <a:rPr kumimoji="0" lang="en-US" altLang="ko-KR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Gulim" panose="020B0600000101010101" pitchFamily="34" charset="-127"/>
                  <a:cs typeface="Arial" panose="020B0604020202020204" pitchFamily="34" charset="0"/>
                </a:rPr>
                <a:t>-ERK</a:t>
              </a:r>
              <a:endPara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 Box 16">
            <a:extLst>
              <a:ext uri="{FF2B5EF4-FFF2-40B4-BE49-F238E27FC236}">
                <a16:creationId xmlns:a16="http://schemas.microsoft.com/office/drawing/2014/main" id="{F279683D-AF20-4DD2-AEB9-B492D884AE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52557" y="5428407"/>
            <a:ext cx="1504883" cy="299480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Apoptosis</a:t>
            </a: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3">
            <a:extLst>
              <a:ext uri="{FF2B5EF4-FFF2-40B4-BE49-F238E27FC236}">
                <a16:creationId xmlns:a16="http://schemas.microsoft.com/office/drawing/2014/main" id="{B5B785F1-BFA6-4F99-8165-0D639C34B925}"/>
              </a:ext>
            </a:extLst>
          </p:cNvPr>
          <p:cNvSpPr>
            <a:spLocks noChangeShapeType="1"/>
          </p:cNvSpPr>
          <p:nvPr/>
        </p:nvSpPr>
        <p:spPr bwMode="auto">
          <a:xfrm>
            <a:off x="6768130" y="2279007"/>
            <a:ext cx="660" cy="25789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2">
            <a:extLst>
              <a:ext uri="{FF2B5EF4-FFF2-40B4-BE49-F238E27FC236}">
                <a16:creationId xmlns:a16="http://schemas.microsoft.com/office/drawing/2014/main" id="{9771B4E2-C217-45AB-AD41-840BF2AC1D2D}"/>
              </a:ext>
            </a:extLst>
          </p:cNvPr>
          <p:cNvSpPr>
            <a:spLocks noChangeShapeType="1"/>
          </p:cNvSpPr>
          <p:nvPr/>
        </p:nvSpPr>
        <p:spPr bwMode="auto">
          <a:xfrm>
            <a:off x="6768130" y="2760159"/>
            <a:ext cx="660" cy="25789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Group 41"/>
          <p:cNvGrpSpPr/>
          <p:nvPr/>
        </p:nvGrpSpPr>
        <p:grpSpPr>
          <a:xfrm>
            <a:off x="6432138" y="4742607"/>
            <a:ext cx="680498" cy="379683"/>
            <a:chOff x="6209510" y="4742607"/>
            <a:chExt cx="680498" cy="379683"/>
          </a:xfrm>
        </p:grpSpPr>
        <p:sp>
          <p:nvSpPr>
            <p:cNvPr id="8" name="Oval 23">
              <a:extLst>
                <a:ext uri="{FF2B5EF4-FFF2-40B4-BE49-F238E27FC236}">
                  <a16:creationId xmlns:a16="http://schemas.microsoft.com/office/drawing/2014/main" id="{C5294200-DE11-45EB-9F67-C7533DD91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9510" y="4783672"/>
              <a:ext cx="680498" cy="287598"/>
            </a:xfrm>
            <a:prstGeom prst="ellipse">
              <a:avLst/>
            </a:prstGeom>
            <a:gradFill rotWithShape="1">
              <a:gsLst>
                <a:gs pos="0">
                  <a:schemeClr val="accent1">
                    <a:lumMod val="40000"/>
                    <a:lumOff val="60000"/>
                  </a:schemeClr>
                </a:gs>
                <a:gs pos="97000">
                  <a:schemeClr val="accent1">
                    <a:lumMod val="40000"/>
                    <a:lumOff val="60000"/>
                  </a:schemeClr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 Box 9">
              <a:extLst>
                <a:ext uri="{FF2B5EF4-FFF2-40B4-BE49-F238E27FC236}">
                  <a16:creationId xmlns:a16="http://schemas.microsoft.com/office/drawing/2014/main" id="{3EACFF0F-0074-4270-8D00-6732AFA3EF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81780" y="4742607"/>
              <a:ext cx="508228" cy="3796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12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Gulim" panose="020B0600000101010101" pitchFamily="34" charset="-127"/>
                  <a:cs typeface="Arial" panose="020B0604020202020204" pitchFamily="34" charset="0"/>
                </a:rPr>
                <a:t>Fas</a:t>
              </a:r>
              <a:endPara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6680527" y="4356908"/>
            <a:ext cx="182880" cy="368528"/>
            <a:chOff x="6704380" y="4356908"/>
            <a:chExt cx="182880" cy="368528"/>
          </a:xfrm>
        </p:grpSpPr>
        <p:sp>
          <p:nvSpPr>
            <p:cNvPr id="23" name="Line 8">
              <a:extLst>
                <a:ext uri="{FF2B5EF4-FFF2-40B4-BE49-F238E27FC236}">
                  <a16:creationId xmlns:a16="http://schemas.microsoft.com/office/drawing/2014/main" id="{01B7B60E-5D05-4581-8676-99CF48FD57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91890" y="4356908"/>
              <a:ext cx="7040" cy="35416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Line 7">
              <a:extLst>
                <a:ext uri="{FF2B5EF4-FFF2-40B4-BE49-F238E27FC236}">
                  <a16:creationId xmlns:a16="http://schemas.microsoft.com/office/drawing/2014/main" id="{C70CD6B5-0DD8-497E-B5FC-BFF2B1F255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4380" y="4724720"/>
              <a:ext cx="182880" cy="716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Line 6">
            <a:extLst>
              <a:ext uri="{FF2B5EF4-FFF2-40B4-BE49-F238E27FC236}">
                <a16:creationId xmlns:a16="http://schemas.microsoft.com/office/drawing/2014/main" id="{8AA968F6-09C4-4E5E-AFA2-CEC4098E6E23}"/>
              </a:ext>
            </a:extLst>
          </p:cNvPr>
          <p:cNvSpPr>
            <a:spLocks noChangeShapeType="1"/>
          </p:cNvSpPr>
          <p:nvPr/>
        </p:nvSpPr>
        <p:spPr bwMode="auto">
          <a:xfrm>
            <a:off x="6778596" y="5135497"/>
            <a:ext cx="660" cy="257181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 Box 12">
            <a:extLst>
              <a:ext uri="{FF2B5EF4-FFF2-40B4-BE49-F238E27FC236}">
                <a16:creationId xmlns:a16="http://schemas.microsoft.com/office/drawing/2014/main" id="{3CFE541F-B73C-4C7F-8FC1-4CFA4E8627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8843" y="5267525"/>
            <a:ext cx="1378965" cy="477386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anose="020B0600000101010101" pitchFamily="34" charset="-127"/>
                <a:cs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dhesion</a:t>
            </a:r>
            <a:r>
              <a:rPr lang="fr-F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</a:p>
          <a:p>
            <a:r>
              <a:rPr lang="fr-F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hemotaxis</a:t>
            </a:r>
            <a:endParaRPr lang="fr-F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Group 75"/>
          <p:cNvGrpSpPr/>
          <p:nvPr/>
        </p:nvGrpSpPr>
        <p:grpSpPr>
          <a:xfrm>
            <a:off x="1405719" y="1247953"/>
            <a:ext cx="655133" cy="286447"/>
            <a:chOff x="1405719" y="1247953"/>
            <a:chExt cx="655133" cy="286447"/>
          </a:xfrm>
        </p:grpSpPr>
        <p:sp>
          <p:nvSpPr>
            <p:cNvPr id="107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1618806" y="1034866"/>
              <a:ext cx="178786" cy="60496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93435" y="1334881"/>
              <a:ext cx="67417" cy="199519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cxnSp>
        <p:nvCxnSpPr>
          <p:cNvPr id="122" name="Straight Arrow Connector 121"/>
          <p:cNvCxnSpPr/>
          <p:nvPr/>
        </p:nvCxnSpPr>
        <p:spPr>
          <a:xfrm>
            <a:off x="7081311" y="3689221"/>
            <a:ext cx="1199840" cy="1462947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6" name="Straight Arrow Connector 145"/>
          <p:cNvCxnSpPr/>
          <p:nvPr/>
        </p:nvCxnSpPr>
        <p:spPr>
          <a:xfrm>
            <a:off x="2425085" y="3069752"/>
            <a:ext cx="49679" cy="310896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8" name="Straight Arrow Connector 147"/>
          <p:cNvCxnSpPr/>
          <p:nvPr/>
        </p:nvCxnSpPr>
        <p:spPr>
          <a:xfrm>
            <a:off x="1109694" y="4333055"/>
            <a:ext cx="0" cy="1828800"/>
          </a:xfrm>
          <a:prstGeom prst="straightConnector1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0" name="TextBox 149"/>
          <p:cNvSpPr txBox="1"/>
          <p:nvPr/>
        </p:nvSpPr>
        <p:spPr>
          <a:xfrm>
            <a:off x="7359644" y="27435"/>
            <a:ext cx="2002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+ L-Arginine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7509255" y="1817937"/>
            <a:ext cx="1719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itrulin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22">
            <a:extLst>
              <a:ext uri="{FF2B5EF4-FFF2-40B4-BE49-F238E27FC236}">
                <a16:creationId xmlns:a16="http://schemas.microsoft.com/office/drawing/2014/main" id="{B5DEBE26-7E34-4649-8101-796B79F681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5836" y="1413946"/>
            <a:ext cx="1190951" cy="4144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3`,5`cGMP</a:t>
            </a: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21">
            <a:extLst>
              <a:ext uri="{FF2B5EF4-FFF2-40B4-BE49-F238E27FC236}">
                <a16:creationId xmlns:a16="http://schemas.microsoft.com/office/drawing/2014/main" id="{A05F0931-572F-491C-BF29-8C1F23BD08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30138" y="518598"/>
            <a:ext cx="656408" cy="413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rPr>
              <a:t>GTP</a:t>
            </a: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 rot="5400000">
            <a:off x="7363775" y="1171268"/>
            <a:ext cx="1129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S</a:t>
            </a:r>
          </a:p>
        </p:txBody>
      </p:sp>
      <p:sp>
        <p:nvSpPr>
          <p:cNvPr id="154" name="Curved Up Arrow 153"/>
          <p:cNvSpPr/>
          <p:nvPr/>
        </p:nvSpPr>
        <p:spPr>
          <a:xfrm rot="5400000" flipH="1">
            <a:off x="5879220" y="920984"/>
            <a:ext cx="937924" cy="306518"/>
          </a:xfrm>
          <a:prstGeom prst="curved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794891" y="148539"/>
            <a:ext cx="1666566" cy="1206136"/>
            <a:chOff x="9906534" y="2379470"/>
            <a:chExt cx="1508488" cy="889000"/>
          </a:xfrm>
        </p:grpSpPr>
        <p:sp>
          <p:nvSpPr>
            <p:cNvPr id="17" name="AutoShape 14">
              <a:extLst>
                <a:ext uri="{FF2B5EF4-FFF2-40B4-BE49-F238E27FC236}">
                  <a16:creationId xmlns:a16="http://schemas.microsoft.com/office/drawing/2014/main" id="{5C8BB565-859F-49DD-A946-1020502E09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6534" y="2379470"/>
              <a:ext cx="1444894" cy="889000"/>
            </a:xfrm>
            <a:prstGeom prst="irregularSeal2">
              <a:avLst/>
            </a:prstGeom>
            <a:gradFill>
              <a:gsLst>
                <a:gs pos="27000">
                  <a:srgbClr val="FFFFFF"/>
                </a:gs>
                <a:gs pos="100000">
                  <a:srgbClr val="FFC0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10096674" y="2712023"/>
              <a:ext cx="1318348" cy="249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adalafil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4" name="Curved Up Arrow 73"/>
          <p:cNvSpPr/>
          <p:nvPr/>
        </p:nvSpPr>
        <p:spPr>
          <a:xfrm rot="16200000" flipH="1">
            <a:off x="7123111" y="956551"/>
            <a:ext cx="937924" cy="306518"/>
          </a:xfrm>
          <a:prstGeom prst="curved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Line 11">
            <a:extLst>
              <a:ext uri="{FF2B5EF4-FFF2-40B4-BE49-F238E27FC236}">
                <a16:creationId xmlns:a16="http://schemas.microsoft.com/office/drawing/2014/main" id="{479522F8-05B7-4D83-A563-EC675D635FD3}"/>
              </a:ext>
            </a:extLst>
          </p:cNvPr>
          <p:cNvSpPr>
            <a:spLocks noChangeShapeType="1"/>
          </p:cNvSpPr>
          <p:nvPr/>
        </p:nvSpPr>
        <p:spPr bwMode="auto">
          <a:xfrm>
            <a:off x="7788088" y="304434"/>
            <a:ext cx="10504" cy="1463995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ounded Rectangle 38"/>
          <p:cNvSpPr/>
          <p:nvPr/>
        </p:nvSpPr>
        <p:spPr>
          <a:xfrm>
            <a:off x="6360733" y="3977057"/>
            <a:ext cx="782218" cy="362516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21</a:t>
            </a:r>
          </a:p>
        </p:txBody>
      </p:sp>
      <p:grpSp>
        <p:nvGrpSpPr>
          <p:cNvPr id="79" name="Group 78"/>
          <p:cNvGrpSpPr/>
          <p:nvPr/>
        </p:nvGrpSpPr>
        <p:grpSpPr>
          <a:xfrm>
            <a:off x="6233181" y="3326269"/>
            <a:ext cx="1039717" cy="397592"/>
            <a:chOff x="6172732" y="3807055"/>
            <a:chExt cx="1039717" cy="397592"/>
          </a:xfrm>
        </p:grpSpPr>
        <p:sp>
          <p:nvSpPr>
            <p:cNvPr id="80" name="Oval 24">
              <a:extLst>
                <a:ext uri="{FF2B5EF4-FFF2-40B4-BE49-F238E27FC236}">
                  <a16:creationId xmlns:a16="http://schemas.microsoft.com/office/drawing/2014/main" id="{A3B150BD-F36A-45FA-A98E-60E53B0C4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2732" y="3828159"/>
              <a:ext cx="898433" cy="303485"/>
            </a:xfrm>
            <a:prstGeom prst="ellipse">
              <a:avLst/>
            </a:prstGeom>
            <a:gradFill rotWithShape="1">
              <a:gsLst>
                <a:gs pos="0">
                  <a:srgbClr val="FF99FF"/>
                </a:gs>
                <a:gs pos="50000">
                  <a:srgbClr val="FFFFFF"/>
                </a:gs>
                <a:gs pos="100000">
                  <a:srgbClr val="FF99FF"/>
                </a:gs>
              </a:gsLst>
              <a:lin ang="5400000" scaled="1"/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 Box 17">
              <a:extLst>
                <a:ext uri="{FF2B5EF4-FFF2-40B4-BE49-F238E27FC236}">
                  <a16:creationId xmlns:a16="http://schemas.microsoft.com/office/drawing/2014/main" id="{CB42FBBD-79D6-4505-9630-E3D53948B5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64514" y="3807055"/>
              <a:ext cx="947935" cy="397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1200" b="1" dirty="0">
                  <a:solidFill>
                    <a:srgbClr val="000000"/>
                  </a:solidFill>
                  <a:latin typeface="Arial" panose="020B0604020202020204" pitchFamily="34" charset="0"/>
                  <a:ea typeface="Gulim" panose="020B0600000101010101" pitchFamily="34" charset="-127"/>
                  <a:cs typeface="Arial" panose="020B0604020202020204" pitchFamily="34" charset="0"/>
                </a:rPr>
                <a:t>MAPK</a:t>
              </a:r>
              <a:endParaRPr kumimoji="0" lang="en-US" altLang="ko-K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Line 13">
            <a:extLst>
              <a:ext uri="{FF2B5EF4-FFF2-40B4-BE49-F238E27FC236}">
                <a16:creationId xmlns:a16="http://schemas.microsoft.com/office/drawing/2014/main" id="{B5B785F1-BFA6-4F99-8165-0D639C34B925}"/>
              </a:ext>
            </a:extLst>
          </p:cNvPr>
          <p:cNvSpPr>
            <a:spLocks noChangeShapeType="1"/>
          </p:cNvSpPr>
          <p:nvPr/>
        </p:nvSpPr>
        <p:spPr bwMode="auto">
          <a:xfrm>
            <a:off x="6757569" y="3689221"/>
            <a:ext cx="660" cy="25789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Line 13">
            <a:extLst>
              <a:ext uri="{FF2B5EF4-FFF2-40B4-BE49-F238E27FC236}">
                <a16:creationId xmlns:a16="http://schemas.microsoft.com/office/drawing/2014/main" id="{B5B785F1-BFA6-4F99-8165-0D639C34B925}"/>
              </a:ext>
            </a:extLst>
          </p:cNvPr>
          <p:cNvSpPr>
            <a:spLocks noChangeShapeType="1"/>
          </p:cNvSpPr>
          <p:nvPr/>
        </p:nvSpPr>
        <p:spPr bwMode="auto">
          <a:xfrm>
            <a:off x="6756909" y="1732836"/>
            <a:ext cx="660" cy="25789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ine 6">
            <a:extLst>
              <a:ext uri="{FF2B5EF4-FFF2-40B4-BE49-F238E27FC236}">
                <a16:creationId xmlns:a16="http://schemas.microsoft.com/office/drawing/2014/main" id="{8AA968F6-09C4-4E5E-AFA2-CEC4098E6E23}"/>
              </a:ext>
            </a:extLst>
          </p:cNvPr>
          <p:cNvSpPr>
            <a:spLocks noChangeShapeType="1"/>
          </p:cNvSpPr>
          <p:nvPr/>
        </p:nvSpPr>
        <p:spPr bwMode="auto">
          <a:xfrm>
            <a:off x="6767470" y="5886199"/>
            <a:ext cx="660" cy="257181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Line 6">
            <a:extLst>
              <a:ext uri="{FF2B5EF4-FFF2-40B4-BE49-F238E27FC236}">
                <a16:creationId xmlns:a16="http://schemas.microsoft.com/office/drawing/2014/main" id="{8AA968F6-09C4-4E5E-AFA2-CEC4098E6E23}"/>
              </a:ext>
            </a:extLst>
          </p:cNvPr>
          <p:cNvSpPr>
            <a:spLocks noChangeShapeType="1"/>
          </p:cNvSpPr>
          <p:nvPr/>
        </p:nvSpPr>
        <p:spPr bwMode="auto">
          <a:xfrm>
            <a:off x="3458806" y="5605997"/>
            <a:ext cx="0" cy="54298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Line 6">
            <a:extLst>
              <a:ext uri="{FF2B5EF4-FFF2-40B4-BE49-F238E27FC236}">
                <a16:creationId xmlns:a16="http://schemas.microsoft.com/office/drawing/2014/main" id="{8AA968F6-09C4-4E5E-AFA2-CEC4098E6E23}"/>
              </a:ext>
            </a:extLst>
          </p:cNvPr>
          <p:cNvSpPr>
            <a:spLocks noChangeShapeType="1"/>
          </p:cNvSpPr>
          <p:nvPr/>
        </p:nvSpPr>
        <p:spPr bwMode="auto">
          <a:xfrm>
            <a:off x="4523295" y="5635996"/>
            <a:ext cx="0" cy="514794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6">
            <a:extLst>
              <a:ext uri="{FF2B5EF4-FFF2-40B4-BE49-F238E27FC236}">
                <a16:creationId xmlns:a16="http://schemas.microsoft.com/office/drawing/2014/main" id="{8AA968F6-09C4-4E5E-AFA2-CEC4098E6E23}"/>
              </a:ext>
            </a:extLst>
          </p:cNvPr>
          <p:cNvSpPr>
            <a:spLocks noChangeShapeType="1"/>
          </p:cNvSpPr>
          <p:nvPr/>
        </p:nvSpPr>
        <p:spPr bwMode="auto">
          <a:xfrm>
            <a:off x="8291564" y="5908507"/>
            <a:ext cx="660" cy="257181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Line 11">
            <a:extLst>
              <a:ext uri="{FF2B5EF4-FFF2-40B4-BE49-F238E27FC236}">
                <a16:creationId xmlns:a16="http://schemas.microsoft.com/office/drawing/2014/main" id="{E25F2A9C-2E0F-4193-B483-C3C15EF4C38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6237" y="780912"/>
            <a:ext cx="683588" cy="178962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 Box 17">
            <a:extLst>
              <a:ext uri="{FF2B5EF4-FFF2-40B4-BE49-F238E27FC236}">
                <a16:creationId xmlns:a16="http://schemas.microsoft.com/office/drawing/2014/main" id="{CB42FBBD-79D6-4505-9630-E3D53948B5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64188" y="3815239"/>
            <a:ext cx="747161" cy="262572"/>
          </a:xfrm>
          <a:prstGeom prst="rect">
            <a:avLst/>
          </a:prstGeom>
          <a:gradFill rotWithShape="1">
            <a:gsLst>
              <a:gs pos="0">
                <a:srgbClr val="9999FF"/>
              </a:gs>
              <a:gs pos="50000">
                <a:srgbClr val="FFFFFF"/>
              </a:gs>
              <a:gs pos="100000">
                <a:srgbClr val="9999FF"/>
              </a:gs>
            </a:gsLst>
            <a:lin ang="5400000" scaled="1"/>
          </a:gra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defPPr>
              <a:defRPr lang="en-US"/>
            </a:defPPr>
            <a:lvl1pPr marR="0" lvl="0" indent="0" algn="ctr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kumimoji="0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Gulim" panose="020B0600000101010101" pitchFamily="34" charset="-127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latin typeface="Arial" panose="020B0604020202020204" pitchFamily="34" charset="0"/>
              </a:defRPr>
            </a:lvl9pPr>
          </a:lstStyle>
          <a:p>
            <a:r>
              <a:rPr lang="en-US" altLang="ko-KR" dirty="0"/>
              <a:t>STAT3</a:t>
            </a:r>
          </a:p>
        </p:txBody>
      </p:sp>
      <p:sp>
        <p:nvSpPr>
          <p:cNvPr id="108" name="Line 11">
            <a:extLst>
              <a:ext uri="{FF2B5EF4-FFF2-40B4-BE49-F238E27FC236}">
                <a16:creationId xmlns:a16="http://schemas.microsoft.com/office/drawing/2014/main" id="{99A9770C-F9B5-4097-99F7-C595B3BEA6D2}"/>
              </a:ext>
            </a:extLst>
          </p:cNvPr>
          <p:cNvSpPr>
            <a:spLocks noChangeShapeType="1"/>
          </p:cNvSpPr>
          <p:nvPr/>
        </p:nvSpPr>
        <p:spPr bwMode="auto">
          <a:xfrm>
            <a:off x="2938850" y="1371334"/>
            <a:ext cx="1506160" cy="1165571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098" y="947287"/>
            <a:ext cx="1086621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MD3100</a:t>
            </a:r>
          </a:p>
        </p:txBody>
      </p:sp>
      <p:sp>
        <p:nvSpPr>
          <p:cNvPr id="125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7830" y="3727377"/>
            <a:ext cx="1086621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0126</a:t>
            </a:r>
          </a:p>
        </p:txBody>
      </p:sp>
      <p:sp>
        <p:nvSpPr>
          <p:cNvPr id="130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5009" y="1559511"/>
            <a:ext cx="1086621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T5823</a:t>
            </a:r>
          </a:p>
        </p:txBody>
      </p:sp>
      <p:grpSp>
        <p:nvGrpSpPr>
          <p:cNvPr id="65" name="Group 64"/>
          <p:cNvGrpSpPr/>
          <p:nvPr/>
        </p:nvGrpSpPr>
        <p:grpSpPr>
          <a:xfrm>
            <a:off x="5552981" y="1852214"/>
            <a:ext cx="621424" cy="284297"/>
            <a:chOff x="5552981" y="1852214"/>
            <a:chExt cx="621424" cy="284297"/>
          </a:xfrm>
        </p:grpSpPr>
        <p:sp>
          <p:nvSpPr>
            <p:cNvPr id="133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5766068" y="1639127"/>
              <a:ext cx="178786" cy="60496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40697" y="1944530"/>
              <a:ext cx="33708" cy="191981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145" name="Group 144"/>
          <p:cNvGrpSpPr/>
          <p:nvPr/>
        </p:nvGrpSpPr>
        <p:grpSpPr>
          <a:xfrm rot="19307253">
            <a:off x="5849256" y="4258208"/>
            <a:ext cx="460104" cy="172858"/>
            <a:chOff x="5745737" y="1931934"/>
            <a:chExt cx="460104" cy="172858"/>
          </a:xfrm>
        </p:grpSpPr>
        <p:sp>
          <p:nvSpPr>
            <p:cNvPr id="147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5902306" y="1775365"/>
              <a:ext cx="99066" cy="412204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rot="2292747" flipH="1" flipV="1">
              <a:off x="6131286" y="1956731"/>
              <a:ext cx="74555" cy="148061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143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4217" y="4254572"/>
            <a:ext cx="1292829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miR-21</a:t>
            </a:r>
          </a:p>
        </p:txBody>
      </p:sp>
      <p:grpSp>
        <p:nvGrpSpPr>
          <p:cNvPr id="156" name="Group 155"/>
          <p:cNvGrpSpPr/>
          <p:nvPr/>
        </p:nvGrpSpPr>
        <p:grpSpPr>
          <a:xfrm rot="20770071">
            <a:off x="5917670" y="4916655"/>
            <a:ext cx="424518" cy="208163"/>
            <a:chOff x="5745737" y="1931934"/>
            <a:chExt cx="424518" cy="208163"/>
          </a:xfrm>
        </p:grpSpPr>
        <p:sp>
          <p:nvSpPr>
            <p:cNvPr id="157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5902306" y="1775365"/>
              <a:ext cx="99066" cy="412204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rot="829929" flipV="1">
              <a:off x="6169275" y="1955500"/>
              <a:ext cx="980" cy="184597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159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8840" y="4802132"/>
            <a:ext cx="1111843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as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0" name="Group 159"/>
          <p:cNvGrpSpPr/>
          <p:nvPr/>
        </p:nvGrpSpPr>
        <p:grpSpPr>
          <a:xfrm rot="9054822">
            <a:off x="8065429" y="740580"/>
            <a:ext cx="417265" cy="213698"/>
            <a:chOff x="1643587" y="1320702"/>
            <a:chExt cx="417265" cy="213698"/>
          </a:xfrm>
        </p:grpSpPr>
        <p:sp>
          <p:nvSpPr>
            <p:cNvPr id="161" name="Line 11">
              <a:extLst>
                <a:ext uri="{FF2B5EF4-FFF2-40B4-BE49-F238E27FC236}">
                  <a16:creationId xmlns:a16="http://schemas.microsoft.com/office/drawing/2014/main" id="{971DBABF-DE7D-4744-8A72-DCD61BA36A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6200000" flipH="1">
              <a:off x="1774114" y="1190175"/>
              <a:ext cx="106038" cy="367091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9F17E3CD-DF25-49AB-8E64-24236D1C12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93435" y="1334881"/>
              <a:ext cx="67417" cy="199519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 type="non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163" name="Oval 23">
            <a:extLst>
              <a:ext uri="{FF2B5EF4-FFF2-40B4-BE49-F238E27FC236}">
                <a16:creationId xmlns:a16="http://schemas.microsoft.com/office/drawing/2014/main" id="{C5294200-DE11-45EB-9F67-C7533DD91D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7397" y="594019"/>
            <a:ext cx="1086621" cy="346649"/>
          </a:xfrm>
          <a:prstGeom prst="ellipse">
            <a:avLst/>
          </a:prstGeom>
          <a:gradFill rotWithShape="1">
            <a:gsLst>
              <a:gs pos="0">
                <a:srgbClr val="FF79AF"/>
              </a:gs>
              <a:gs pos="100000">
                <a:srgbClr val="FFBDD8"/>
              </a:gs>
              <a:gs pos="0">
                <a:srgbClr val="FFFFFF"/>
              </a:gs>
              <a:gs pos="100000">
                <a:srgbClr val="FF0066"/>
              </a:gs>
            </a:gsLst>
            <a:path path="shape">
              <a:fillToRect l="50000" t="50000" r="50000" b="50000"/>
            </a:path>
          </a:gra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-NAME</a:t>
            </a:r>
          </a:p>
        </p:txBody>
      </p:sp>
      <p:sp>
        <p:nvSpPr>
          <p:cNvPr id="164" name="Line 11">
            <a:extLst>
              <a:ext uri="{FF2B5EF4-FFF2-40B4-BE49-F238E27FC236}">
                <a16:creationId xmlns:a16="http://schemas.microsoft.com/office/drawing/2014/main" id="{479522F8-05B7-4D83-A563-EC675D635FD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31689" y="3573512"/>
            <a:ext cx="423782" cy="20754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D83B490-DEB0-4AE2-976E-DBDAD173EDC0}"/>
              </a:ext>
            </a:extLst>
          </p:cNvPr>
          <p:cNvSpPr txBox="1"/>
          <p:nvPr/>
        </p:nvSpPr>
        <p:spPr>
          <a:xfrm rot="5400000">
            <a:off x="5505187" y="1205441"/>
            <a:ext cx="11221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DE5A</a:t>
            </a:r>
          </a:p>
        </p:txBody>
      </p:sp>
    </p:spTree>
    <p:extLst>
      <p:ext uri="{BB962C8B-B14F-4D97-AF65-F5344CB8AC3E}">
        <p14:creationId xmlns:p14="http://schemas.microsoft.com/office/powerpoint/2010/main" val="3383464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7</TotalTime>
  <Words>60</Words>
  <Application>Microsoft Office PowerPoint</Application>
  <PresentationFormat>A4 Paper (210x297 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Gulim</vt:lpstr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lan Dang</dc:creator>
  <cp:lastModifiedBy>Lanlan Dang</cp:lastModifiedBy>
  <cp:revision>35</cp:revision>
  <dcterms:created xsi:type="dcterms:W3CDTF">2017-08-10T03:29:44Z</dcterms:created>
  <dcterms:modified xsi:type="dcterms:W3CDTF">2017-08-12T15:42:58Z</dcterms:modified>
</cp:coreProperties>
</file>